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5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3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33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F2926FA-077E-47B9-8A41-A7DFC71F4A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1F0C8E5-C154-40F8-9B4A-B31E996C9A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FA16DC5-4AA8-4462-BE1F-134D5AF1E2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99251-A514-4F8E-AB1A-A34D0A96F656}" type="datetimeFigureOut">
              <a:rPr lang="ko-KR" altLang="en-US" smtClean="0"/>
              <a:t>2023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32B111E-7923-4E1E-A928-1F4AC663B1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4309E55-BCAE-4C43-964D-CE6EA5A0FC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D3DA-1060-4992-933C-CD1887FF49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0949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60E2635-789B-4BAA-88EC-C05AA6440C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8E73791-DE20-464D-98A6-AF1456B683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3122C60-825F-42FF-9512-848C2FB976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99251-A514-4F8E-AB1A-A34D0A96F656}" type="datetimeFigureOut">
              <a:rPr lang="ko-KR" altLang="en-US" smtClean="0"/>
              <a:t>2023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F06C07A-BCF2-40D7-8398-FA33D1274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C181D63-634C-45A6-B7FA-319C18C76C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D3DA-1060-4992-933C-CD1887FF49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6167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A4AB2E41-C163-48BC-8FB3-C8435BCD96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0F2F829-4C87-44E6-A676-071E6BA247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8FE19C9-8B68-4BA0-9C49-63B31645E5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99251-A514-4F8E-AB1A-A34D0A96F656}" type="datetimeFigureOut">
              <a:rPr lang="ko-KR" altLang="en-US" smtClean="0"/>
              <a:t>2023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4CBCB92-6C56-4363-B24A-C9D95CB3F6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64E1475-433C-4707-8766-0627C31AC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D3DA-1060-4992-933C-CD1887FF49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6057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4FE2BFF-CC5A-4F0B-86E7-9B8009A53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77C2FB6-7F59-49F7-B945-9AE7F5BFE6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2A9524F-F391-4D3A-8517-8F01977ABE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99251-A514-4F8E-AB1A-A34D0A96F656}" type="datetimeFigureOut">
              <a:rPr lang="ko-KR" altLang="en-US" smtClean="0"/>
              <a:t>2023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01FD8AB-BDD4-49D8-99CD-ABA3072829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AC2BAC1-9DE3-45AA-9567-5F9B6F14AD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D3DA-1060-4992-933C-CD1887FF49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36104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9FB738F-DEAA-468E-A79A-B6E99AD4F7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4ECB763-C99B-4190-8476-C67D051E00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7D25C98-8C8F-421E-9C81-9546E9294A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99251-A514-4F8E-AB1A-A34D0A96F656}" type="datetimeFigureOut">
              <a:rPr lang="ko-KR" altLang="en-US" smtClean="0"/>
              <a:t>2023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A91FF3F-C186-4C50-8C02-E844CC27E3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05FD1A0-03F7-43D9-B13C-FF1E44979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D3DA-1060-4992-933C-CD1887FF49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7543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91CD528-E583-458C-B466-8114881219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D44D6CE-9532-44E6-B809-5EE1034E6D6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2731746-2E13-489D-A520-C6A7D5BF9E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CDEAD2D-C9AE-429A-8A79-955321A7D9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99251-A514-4F8E-AB1A-A34D0A96F656}" type="datetimeFigureOut">
              <a:rPr lang="ko-KR" altLang="en-US" smtClean="0"/>
              <a:t>2023-07-1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BB52E34-07E7-45BC-A2DA-C8134802B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D31B2C6-1016-4F6C-8968-099CE09B93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D3DA-1060-4992-933C-CD1887FF49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8701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595E75D-37A7-421F-9BB7-B505534AA6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FCB1F2C-9F00-4B50-8F6B-E7645C6886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7FBDBE8-48C6-46CC-BCEB-4EE15F4FC2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F1A78463-BCFB-491B-A2AC-4407D084CF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EC125D78-6317-44D7-AA88-DE2EBA63BA8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3B8525AC-FE80-4709-8833-F1A91C51E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99251-A514-4F8E-AB1A-A34D0A96F656}" type="datetimeFigureOut">
              <a:rPr lang="ko-KR" altLang="en-US" smtClean="0"/>
              <a:t>2023-07-15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BCC8999F-9E0F-41EB-ADD2-7458267A0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5807EC40-1B7B-44F6-881D-FC6ED6EE2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D3DA-1060-4992-933C-CD1887FF49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7968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41272E1-DE52-4B56-ABBB-C82EDA87C4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F6E9D08-3675-407C-97A5-77DE6FDE6C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99251-A514-4F8E-AB1A-A34D0A96F656}" type="datetimeFigureOut">
              <a:rPr lang="ko-KR" altLang="en-US" smtClean="0"/>
              <a:t>2023-07-15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ABD29540-6AC6-4F12-8B36-9F6FE90609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EE1767B4-3EE2-4DD1-98F0-F3F8F081E5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D3DA-1060-4992-933C-CD1887FF49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75406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5644D0D-F1FC-4A44-8C28-C9C85184E9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99251-A514-4F8E-AB1A-A34D0A96F656}" type="datetimeFigureOut">
              <a:rPr lang="ko-KR" altLang="en-US" smtClean="0"/>
              <a:t>2023-07-15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EA974AC9-62B7-4FBE-B47F-64F5735B1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8171D12-DA24-4DFB-8AC7-245FD2171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D3DA-1060-4992-933C-CD1887FF49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81114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B395A66-03BB-4A30-AD7C-EA399DF22C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066A425-3080-4F2F-B823-EB3914D191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2BAD38B-356F-435A-9075-411FCA701F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A87986D-F0AE-4C13-BDF6-6018E47F7A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99251-A514-4F8E-AB1A-A34D0A96F656}" type="datetimeFigureOut">
              <a:rPr lang="ko-KR" altLang="en-US" smtClean="0"/>
              <a:t>2023-07-1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A11B2F7-22AE-43E6-B627-7398FC3C90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9267D38-FB52-4491-9EA9-75B6F682C1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D3DA-1060-4992-933C-CD1887FF49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201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2BE8D5E-ED65-4949-9C13-80260CDDAF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B4C1F5B1-EE9B-41F3-B931-9A57691378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C33174A-C3F1-4AC2-B402-336E1DA719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1683EB9-504A-448A-BF2D-9D5A6E9AEE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99251-A514-4F8E-AB1A-A34D0A96F656}" type="datetimeFigureOut">
              <a:rPr lang="ko-KR" altLang="en-US" smtClean="0"/>
              <a:t>2023-07-1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6CEF69E-BF63-4829-8A35-AE14BF64D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3F753B4-0CDB-4279-BBC7-E87DBC8E77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4D3DA-1060-4992-933C-CD1887FF49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5182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5B71FAD1-00E2-4531-B171-87A71C9E13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ACA29A7-3077-4DC4-AF32-DEA6016111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483A8D0-0C19-43C0-AB5D-564165ECDD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99251-A514-4F8E-AB1A-A34D0A96F656}" type="datetimeFigureOut">
              <a:rPr lang="ko-KR" altLang="en-US" smtClean="0"/>
              <a:t>2023-07-1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92CFA01-B3D8-4E81-B51E-24FABED5B4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B29F085-5EE6-4995-AD8E-62A1DCCF14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A4D3DA-1060-4992-933C-CD1887FF49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32689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그룹 34">
            <a:extLst>
              <a:ext uri="{FF2B5EF4-FFF2-40B4-BE49-F238E27FC236}">
                <a16:creationId xmlns:a16="http://schemas.microsoft.com/office/drawing/2014/main" id="{83D6D36D-B7A0-49A7-81C0-A4B834C8142A}"/>
              </a:ext>
            </a:extLst>
          </p:cNvPr>
          <p:cNvGrpSpPr/>
          <p:nvPr/>
        </p:nvGrpSpPr>
        <p:grpSpPr>
          <a:xfrm>
            <a:off x="1600200" y="1209365"/>
            <a:ext cx="7727009" cy="3807415"/>
            <a:chOff x="1031882" y="1458093"/>
            <a:chExt cx="7727009" cy="3807415"/>
          </a:xfrm>
        </p:grpSpPr>
        <p:sp>
          <p:nvSpPr>
            <p:cNvPr id="3" name="직사각형 2">
              <a:extLst>
                <a:ext uri="{FF2B5EF4-FFF2-40B4-BE49-F238E27FC236}">
                  <a16:creationId xmlns:a16="http://schemas.microsoft.com/office/drawing/2014/main" id="{942A9C4F-7EF6-409A-A8B7-ABD9FCB084BD}"/>
                </a:ext>
              </a:extLst>
            </p:cNvPr>
            <p:cNvSpPr/>
            <p:nvPr/>
          </p:nvSpPr>
          <p:spPr>
            <a:xfrm>
              <a:off x="2508563" y="2681548"/>
              <a:ext cx="1441420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6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1 data</a:t>
              </a:r>
            </a:p>
            <a:p>
              <a:pPr algn="ctr"/>
              <a:r>
                <a:rPr lang="en-US" altLang="ko-KR" sz="16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4,310 patients</a:t>
              </a:r>
            </a:p>
          </p:txBody>
        </p:sp>
        <p:sp>
          <p:nvSpPr>
            <p:cNvPr id="15" name="직사각형 14">
              <a:extLst>
                <a:ext uri="{FF2B5EF4-FFF2-40B4-BE49-F238E27FC236}">
                  <a16:creationId xmlns:a16="http://schemas.microsoft.com/office/drawing/2014/main" id="{E1A74950-F7E9-4DDF-914D-D37756A2A7E0}"/>
                </a:ext>
              </a:extLst>
            </p:cNvPr>
            <p:cNvSpPr/>
            <p:nvPr/>
          </p:nvSpPr>
          <p:spPr>
            <a:xfrm rot="20572889">
              <a:off x="4059527" y="2335344"/>
              <a:ext cx="1939281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16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3.0% </a:t>
              </a:r>
              <a:r>
                <a:rPr lang="en-US" altLang="ko-KR" sz="14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[39.2 – 47.2]</a:t>
              </a:r>
              <a:endParaRPr lang="ko-KR" altLang="en-US" sz="1400" dirty="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" name="직선 화살표 연결선 19">
              <a:extLst>
                <a:ext uri="{FF2B5EF4-FFF2-40B4-BE49-F238E27FC236}">
                  <a16:creationId xmlns:a16="http://schemas.microsoft.com/office/drawing/2014/main" id="{6174F891-4330-4500-A9E4-1E14744E8EE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59495" y="2312814"/>
              <a:ext cx="2413988" cy="762406"/>
            </a:xfrm>
            <a:prstGeom prst="straightConnector1">
              <a:avLst/>
            </a:prstGeom>
            <a:ln>
              <a:solidFill>
                <a:schemeClr val="bg1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DBEFE55-C34F-4C2B-A390-8173225CAE3C}"/>
                </a:ext>
              </a:extLst>
            </p:cNvPr>
            <p:cNvSpPr txBox="1"/>
            <p:nvPr/>
          </p:nvSpPr>
          <p:spPr>
            <a:xfrm>
              <a:off x="5130613" y="2872703"/>
              <a:ext cx="272643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ild        Moderate     Severe</a:t>
              </a:r>
              <a:endParaRPr lang="ko-KR" altLang="en-US" sz="1600" dirty="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3" name="그림 22">
              <a:extLst>
                <a:ext uri="{FF2B5EF4-FFF2-40B4-BE49-F238E27FC236}">
                  <a16:creationId xmlns:a16="http://schemas.microsoft.com/office/drawing/2014/main" id="{A24C87E2-9E5F-4D1A-BF0B-153EC105121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duotone>
                <a:schemeClr val="accent5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5270977" y="3198650"/>
              <a:ext cx="357360" cy="518621"/>
            </a:xfrm>
            <a:prstGeom prst="rect">
              <a:avLst/>
            </a:prstGeom>
          </p:spPr>
        </p:pic>
        <p:pic>
          <p:nvPicPr>
            <p:cNvPr id="24" name="그림 23">
              <a:extLst>
                <a:ext uri="{FF2B5EF4-FFF2-40B4-BE49-F238E27FC236}">
                  <a16:creationId xmlns:a16="http://schemas.microsoft.com/office/drawing/2014/main" id="{C470BCCF-951B-4076-BDEB-09112F54DA7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6267524" y="3198650"/>
              <a:ext cx="357361" cy="499571"/>
            </a:xfrm>
            <a:prstGeom prst="rect">
              <a:avLst/>
            </a:prstGeom>
          </p:spPr>
        </p:pic>
        <p:pic>
          <p:nvPicPr>
            <p:cNvPr id="25" name="그림 24">
              <a:extLst>
                <a:ext uri="{FF2B5EF4-FFF2-40B4-BE49-F238E27FC236}">
                  <a16:creationId xmlns:a16="http://schemas.microsoft.com/office/drawing/2014/main" id="{5BEB1B12-6C23-49D6-B810-C3B34784508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7216447" y="3198650"/>
              <a:ext cx="357360" cy="518621"/>
            </a:xfrm>
            <a:prstGeom prst="rect">
              <a:avLst/>
            </a:prstGeom>
          </p:spPr>
        </p:pic>
        <p:pic>
          <p:nvPicPr>
            <p:cNvPr id="26" name="그림 25">
              <a:extLst>
                <a:ext uri="{FF2B5EF4-FFF2-40B4-BE49-F238E27FC236}">
                  <a16:creationId xmlns:a16="http://schemas.microsoft.com/office/drawing/2014/main" id="{8393970E-9EB9-488E-A38A-7C8E90E4841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446205" y="1458093"/>
              <a:ext cx="871653" cy="1153806"/>
            </a:xfrm>
            <a:prstGeom prst="rect">
              <a:avLst/>
            </a:prstGeom>
          </p:spPr>
        </p:pic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062612BF-D10C-4BF4-B816-26B7478E30FF}"/>
                </a:ext>
              </a:extLst>
            </p:cNvPr>
            <p:cNvSpPr txBox="1"/>
            <p:nvPr/>
          </p:nvSpPr>
          <p:spPr>
            <a:xfrm>
              <a:off x="5139685" y="3674641"/>
              <a:ext cx="27866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6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4.7%         25.5%        22.4%</a:t>
              </a:r>
              <a:endParaRPr lang="ko-KR" altLang="en-US" sz="1600" dirty="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2BACAE3-2E8A-4F2E-9800-18374BADFFB9}"/>
                </a:ext>
              </a:extLst>
            </p:cNvPr>
            <p:cNvSpPr txBox="1"/>
            <p:nvPr/>
          </p:nvSpPr>
          <p:spPr>
            <a:xfrm>
              <a:off x="7809557" y="3280822"/>
              <a:ext cx="711194" cy="677108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txBody>
            <a:bodyPr wrap="square" tIns="0" bIns="0" rtlCol="0">
              <a:spAutoFit/>
            </a:bodyPr>
            <a:lstStyle/>
            <a:p>
              <a:pPr algn="ctr"/>
              <a:r>
                <a:rPr lang="en-US" altLang="ko-KR" sz="14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rain tumor </a:t>
              </a:r>
              <a:r>
                <a:rPr lang="en-US" altLang="ko-KR" sz="16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9.7%</a:t>
              </a:r>
              <a:endParaRPr lang="ko-KR" altLang="en-US" sz="1400" dirty="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4" name="직선 화살표 연결선 33">
              <a:extLst>
                <a:ext uri="{FF2B5EF4-FFF2-40B4-BE49-F238E27FC236}">
                  <a16:creationId xmlns:a16="http://schemas.microsoft.com/office/drawing/2014/main" id="{AF1FB9F3-96C9-43DB-8F09-9650416F4794}"/>
                </a:ext>
              </a:extLst>
            </p:cNvPr>
            <p:cNvCxnSpPr>
              <a:cxnSpLocks/>
            </p:cNvCxnSpPr>
            <p:nvPr/>
          </p:nvCxnSpPr>
          <p:spPr>
            <a:xfrm>
              <a:off x="7529496" y="3469869"/>
              <a:ext cx="280061" cy="0"/>
            </a:xfrm>
            <a:prstGeom prst="straightConnector1">
              <a:avLst/>
            </a:prstGeom>
            <a:ln>
              <a:solidFill>
                <a:schemeClr val="accent2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169" name="그룹 7168">
              <a:extLst>
                <a:ext uri="{FF2B5EF4-FFF2-40B4-BE49-F238E27FC236}">
                  <a16:creationId xmlns:a16="http://schemas.microsoft.com/office/drawing/2014/main" id="{394A3050-8C4A-48A5-B938-109231CA8848}"/>
                </a:ext>
              </a:extLst>
            </p:cNvPr>
            <p:cNvGrpSpPr/>
            <p:nvPr/>
          </p:nvGrpSpPr>
          <p:grpSpPr>
            <a:xfrm>
              <a:off x="7390580" y="1548331"/>
              <a:ext cx="506192" cy="760912"/>
              <a:chOff x="8172573" y="1271897"/>
              <a:chExt cx="506192" cy="760912"/>
            </a:xfrm>
          </p:grpSpPr>
          <p:pic>
            <p:nvPicPr>
              <p:cNvPr id="62" name="그림 61">
                <a:extLst>
                  <a:ext uri="{FF2B5EF4-FFF2-40B4-BE49-F238E27FC236}">
                    <a16:creationId xmlns:a16="http://schemas.microsoft.com/office/drawing/2014/main" id="{2D7D85C0-57A9-4BB4-BA05-CBED7C1B967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lum bright="70000" contrast="-70000"/>
              </a:blip>
              <a:stretch>
                <a:fillRect/>
              </a:stretch>
            </p:blipFill>
            <p:spPr>
              <a:xfrm>
                <a:off x="8172573" y="1271897"/>
                <a:ext cx="506192" cy="760912"/>
              </a:xfrm>
              <a:prstGeom prst="rect">
                <a:avLst/>
              </a:prstGeom>
            </p:spPr>
          </p:pic>
          <p:pic>
            <p:nvPicPr>
              <p:cNvPr id="77" name="그림 76">
                <a:extLst>
                  <a:ext uri="{FF2B5EF4-FFF2-40B4-BE49-F238E27FC236}">
                    <a16:creationId xmlns:a16="http://schemas.microsoft.com/office/drawing/2014/main" id="{ACCB953A-EC5A-4EF7-A865-9098CA3879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grayscl/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harpenSoften amount="73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8310023" y="1438274"/>
                <a:ext cx="200357" cy="200357"/>
              </a:xfrm>
              <a:prstGeom prst="rect">
                <a:avLst/>
              </a:prstGeom>
            </p:spPr>
          </p:pic>
        </p:grpSp>
        <p:sp>
          <p:nvSpPr>
            <p:cNvPr id="7168" name="TextBox 7167">
              <a:extLst>
                <a:ext uri="{FF2B5EF4-FFF2-40B4-BE49-F238E27FC236}">
                  <a16:creationId xmlns:a16="http://schemas.microsoft.com/office/drawing/2014/main" id="{BED5389E-8FC8-446B-B211-145E100E7982}"/>
                </a:ext>
              </a:extLst>
            </p:cNvPr>
            <p:cNvSpPr txBox="1"/>
            <p:nvPr/>
          </p:nvSpPr>
          <p:spPr>
            <a:xfrm>
              <a:off x="7164660" y="2289050"/>
              <a:ext cx="11274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.4-fold</a:t>
              </a:r>
              <a:endParaRPr lang="ko-KR" altLang="en-US" dirty="0">
                <a:solidFill>
                  <a:schemeClr val="tx1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8" name="그룹 17">
              <a:extLst>
                <a:ext uri="{FF2B5EF4-FFF2-40B4-BE49-F238E27FC236}">
                  <a16:creationId xmlns:a16="http://schemas.microsoft.com/office/drawing/2014/main" id="{60DD1741-C4E8-4A91-BF60-8C92FE674069}"/>
                </a:ext>
              </a:extLst>
            </p:cNvPr>
            <p:cNvGrpSpPr/>
            <p:nvPr/>
          </p:nvGrpSpPr>
          <p:grpSpPr>
            <a:xfrm>
              <a:off x="3433109" y="4157659"/>
              <a:ext cx="5325782" cy="1107849"/>
              <a:chOff x="3637243" y="4090789"/>
              <a:chExt cx="5325782" cy="1107849"/>
            </a:xfrm>
          </p:grpSpPr>
          <p:pic>
            <p:nvPicPr>
              <p:cNvPr id="57" name="그림 56">
                <a:extLst>
                  <a:ext uri="{FF2B5EF4-FFF2-40B4-BE49-F238E27FC236}">
                    <a16:creationId xmlns:a16="http://schemas.microsoft.com/office/drawing/2014/main" id="{9592ED94-A4C5-41FE-AE5B-2AB9C050D27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duotone>
                  <a:schemeClr val="accent2">
                    <a:shade val="45000"/>
                    <a:satMod val="135000"/>
                  </a:schemeClr>
                  <a:prstClr val="white"/>
                </a:duotone>
              </a:blip>
              <a:stretch>
                <a:fillRect/>
              </a:stretch>
            </p:blipFill>
            <p:spPr>
              <a:xfrm>
                <a:off x="4796535" y="4223437"/>
                <a:ext cx="357360" cy="521004"/>
              </a:xfrm>
              <a:prstGeom prst="rect">
                <a:avLst/>
              </a:prstGeom>
            </p:spPr>
          </p:pic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04D79B8E-774F-4930-9A11-F97D562A4163}"/>
                  </a:ext>
                </a:extLst>
              </p:cNvPr>
              <p:cNvSpPr txBox="1"/>
              <p:nvPr/>
            </p:nvSpPr>
            <p:spPr>
              <a:xfrm>
                <a:off x="4975215" y="4090789"/>
                <a:ext cx="398781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efore    Ongoing    After   Cancer-free</a:t>
                </a:r>
                <a:endParaRPr lang="ko-KR" altLang="en-US" sz="16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B0569EB3-FD69-4BB3-B9FD-414F442DB1F4}"/>
                  </a:ext>
                </a:extLst>
              </p:cNvPr>
              <p:cNvSpPr txBox="1"/>
              <p:nvPr/>
            </p:nvSpPr>
            <p:spPr>
              <a:xfrm>
                <a:off x="5139684" y="4476573"/>
                <a:ext cx="356616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6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.9%        33.8%        24.1%     16.4%</a:t>
                </a:r>
                <a:endParaRPr lang="ko-KR" altLang="en-US" sz="16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4F8253DD-7348-4F23-82D0-7E679FE2A3AB}"/>
                  </a:ext>
                </a:extLst>
              </p:cNvPr>
              <p:cNvSpPr txBox="1"/>
              <p:nvPr/>
            </p:nvSpPr>
            <p:spPr>
              <a:xfrm>
                <a:off x="4975221" y="4860084"/>
                <a:ext cx="398780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elf-report 23.6% </a:t>
                </a:r>
                <a:r>
                  <a:rPr lang="en-US" altLang="ko-KR" sz="1600" i="1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s.</a:t>
                </a:r>
                <a:r>
                  <a:rPr lang="ko-KR" altLang="en-US" sz="16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ko-KR" sz="16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6% by Physicians</a:t>
                </a:r>
                <a:endParaRPr lang="ko-KR" altLang="en-US" sz="16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" name="직사각형 3">
                <a:extLst>
                  <a:ext uri="{FF2B5EF4-FFF2-40B4-BE49-F238E27FC236}">
                    <a16:creationId xmlns:a16="http://schemas.microsoft.com/office/drawing/2014/main" id="{F9C50CB8-F36D-4AB2-A252-5F0FB89957C0}"/>
                  </a:ext>
                </a:extLst>
              </p:cNvPr>
              <p:cNvSpPr/>
              <p:nvPr/>
            </p:nvSpPr>
            <p:spPr>
              <a:xfrm>
                <a:off x="3637243" y="4366911"/>
                <a:ext cx="1159292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6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vere CFF</a:t>
                </a:r>
                <a:endParaRPr lang="ko-KR" altLang="en-US" sz="1600" dirty="0"/>
              </a:p>
            </p:txBody>
          </p:sp>
          <p:grpSp>
            <p:nvGrpSpPr>
              <p:cNvPr id="16" name="그룹 15">
                <a:extLst>
                  <a:ext uri="{FF2B5EF4-FFF2-40B4-BE49-F238E27FC236}">
                    <a16:creationId xmlns:a16="http://schemas.microsoft.com/office/drawing/2014/main" id="{543234AB-8905-4C0D-A4AB-3B43FFBDFE21}"/>
                  </a:ext>
                </a:extLst>
              </p:cNvPr>
              <p:cNvGrpSpPr/>
              <p:nvPr/>
            </p:nvGrpSpPr>
            <p:grpSpPr>
              <a:xfrm>
                <a:off x="4928080" y="4735014"/>
                <a:ext cx="202177" cy="341051"/>
                <a:chOff x="4966569" y="4704657"/>
                <a:chExt cx="185433" cy="265946"/>
              </a:xfrm>
            </p:grpSpPr>
            <p:cxnSp>
              <p:nvCxnSpPr>
                <p:cNvPr id="32" name="직선 화살표 연결선 31">
                  <a:extLst>
                    <a:ext uri="{FF2B5EF4-FFF2-40B4-BE49-F238E27FC236}">
                      <a16:creationId xmlns:a16="http://schemas.microsoft.com/office/drawing/2014/main" id="{BF718D62-97A6-41FE-A3A3-E103D1C4F34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66569" y="4970603"/>
                  <a:ext cx="185433" cy="0"/>
                </a:xfrm>
                <a:prstGeom prst="straightConnector1">
                  <a:avLst/>
                </a:prstGeom>
                <a:ln>
                  <a:solidFill>
                    <a:schemeClr val="accent2">
                      <a:lumMod val="75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직선 연결선 9">
                  <a:extLst>
                    <a:ext uri="{FF2B5EF4-FFF2-40B4-BE49-F238E27FC236}">
                      <a16:creationId xmlns:a16="http://schemas.microsoft.com/office/drawing/2014/main" id="{9D20BDE0-9C0F-44A6-99C6-32AB33A4E38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75216" y="4704657"/>
                  <a:ext cx="0" cy="261332"/>
                </a:xfrm>
                <a:prstGeom prst="line">
                  <a:avLst/>
                </a:prstGeom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9" name="그룹 8">
              <a:extLst>
                <a:ext uri="{FF2B5EF4-FFF2-40B4-BE49-F238E27FC236}">
                  <a16:creationId xmlns:a16="http://schemas.microsoft.com/office/drawing/2014/main" id="{994966B7-8EE1-4714-9170-91DF4001B36D}"/>
                </a:ext>
              </a:extLst>
            </p:cNvPr>
            <p:cNvGrpSpPr/>
            <p:nvPr/>
          </p:nvGrpSpPr>
          <p:grpSpPr>
            <a:xfrm>
              <a:off x="1031882" y="3219614"/>
              <a:ext cx="1646606" cy="1515861"/>
              <a:chOff x="1433855" y="3033793"/>
              <a:chExt cx="1646606" cy="1515861"/>
            </a:xfrm>
          </p:grpSpPr>
          <p:pic>
            <p:nvPicPr>
              <p:cNvPr id="14" name="그림 13">
                <a:extLst>
                  <a:ext uri="{FF2B5EF4-FFF2-40B4-BE49-F238E27FC236}">
                    <a16:creationId xmlns:a16="http://schemas.microsoft.com/office/drawing/2014/main" id="{70F174D0-145A-49C4-AEB1-EA6557C7B09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duotone>
                  <a:schemeClr val="accent2">
                    <a:shade val="45000"/>
                    <a:satMod val="135000"/>
                  </a:schemeClr>
                  <a:prstClr val="white"/>
                </a:duotone>
              </a:blip>
              <a:stretch>
                <a:fillRect/>
              </a:stretch>
            </p:blipFill>
            <p:spPr>
              <a:xfrm>
                <a:off x="1665647" y="3033793"/>
                <a:ext cx="1214556" cy="1214556"/>
              </a:xfrm>
              <a:prstGeom prst="rect">
                <a:avLst/>
              </a:prstGeom>
            </p:spPr>
          </p:pic>
          <p:sp>
            <p:nvSpPr>
              <p:cNvPr id="7186" name="TextBox 7185">
                <a:extLst>
                  <a:ext uri="{FF2B5EF4-FFF2-40B4-BE49-F238E27FC236}">
                    <a16:creationId xmlns:a16="http://schemas.microsoft.com/office/drawing/2014/main" id="{60ABA84F-6787-4386-9F6A-1B62B70F69DF}"/>
                  </a:ext>
                </a:extLst>
              </p:cNvPr>
              <p:cNvSpPr txBox="1"/>
              <p:nvPr/>
            </p:nvSpPr>
            <p:spPr>
              <a:xfrm>
                <a:off x="1433855" y="3190557"/>
                <a:ext cx="1646606" cy="9233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ncer-</a:t>
                </a:r>
              </a:p>
              <a:p>
                <a:pPr algn="ctr"/>
                <a:r>
                  <a:rPr lang="en-US" altLang="ko-KR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ed </a:t>
                </a:r>
              </a:p>
              <a:p>
                <a:pPr algn="ctr"/>
                <a:r>
                  <a:rPr lang="en-US" altLang="ko-KR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tigue (CRF)</a:t>
                </a:r>
                <a:endParaRPr lang="ko-KR" altLang="en-US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직사각형 7">
                <a:extLst>
                  <a:ext uri="{FF2B5EF4-FFF2-40B4-BE49-F238E27FC236}">
                    <a16:creationId xmlns:a16="http://schemas.microsoft.com/office/drawing/2014/main" id="{D3C8C649-3EB0-48C4-AB0C-DA44EE6FBDA3}"/>
                  </a:ext>
                </a:extLst>
              </p:cNvPr>
              <p:cNvSpPr/>
              <p:nvPr/>
            </p:nvSpPr>
            <p:spPr>
              <a:xfrm>
                <a:off x="1443670" y="4180322"/>
                <a:ext cx="1479892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ko-KR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ta-analysis</a:t>
                </a:r>
                <a:endParaRPr lang="ko-KR" altLang="en-US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" name="직사각형 12">
              <a:extLst>
                <a:ext uri="{FF2B5EF4-FFF2-40B4-BE49-F238E27FC236}">
                  <a16:creationId xmlns:a16="http://schemas.microsoft.com/office/drawing/2014/main" id="{67D9B784-75CC-4D0B-8C4B-93EFBBEC9DA6}"/>
                </a:ext>
              </a:extLst>
            </p:cNvPr>
            <p:cNvSpPr/>
            <p:nvPr/>
          </p:nvSpPr>
          <p:spPr>
            <a:xfrm>
              <a:off x="3959851" y="3154282"/>
              <a:ext cx="1160894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600" dirty="0">
                  <a:latin typeface="Times New Roman" panose="02020603050405020304" pitchFamily="18" charset="0"/>
                  <a:ea typeface="HY신명조" panose="02030600000101010101" pitchFamily="18" charset="-127"/>
                </a:rPr>
                <a:t>70.7% </a:t>
              </a:r>
            </a:p>
            <a:p>
              <a:pPr algn="ctr"/>
              <a:r>
                <a:rPr lang="en-US" altLang="ko-KR" sz="1600" dirty="0">
                  <a:latin typeface="Times New Roman" panose="02020603050405020304" pitchFamily="18" charset="0"/>
                  <a:ea typeface="HY신명조" panose="02030600000101010101" pitchFamily="18" charset="-127"/>
                </a:rPr>
                <a:t>[60.6-83.3] </a:t>
              </a:r>
              <a:endParaRPr lang="ko-KR" altLang="en-US" sz="1600" dirty="0"/>
            </a:p>
          </p:txBody>
        </p:sp>
        <p:cxnSp>
          <p:nvCxnSpPr>
            <p:cNvPr id="39" name="직선 화살표 연결선 38">
              <a:extLst>
                <a:ext uri="{FF2B5EF4-FFF2-40B4-BE49-F238E27FC236}">
                  <a16:creationId xmlns:a16="http://schemas.microsoft.com/office/drawing/2014/main" id="{25E53A24-D125-43D4-8D46-D197C614C0C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90286" y="3730990"/>
              <a:ext cx="1319184" cy="18550"/>
            </a:xfrm>
            <a:prstGeom prst="straightConnector1">
              <a:avLst/>
            </a:prstGeom>
            <a:ln>
              <a:solidFill>
                <a:schemeClr val="bg1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직사각형 41">
              <a:extLst>
                <a:ext uri="{FF2B5EF4-FFF2-40B4-BE49-F238E27FC236}">
                  <a16:creationId xmlns:a16="http://schemas.microsoft.com/office/drawing/2014/main" id="{8C288F04-B028-4FF1-BD63-4E62F9BB7E69}"/>
                </a:ext>
              </a:extLst>
            </p:cNvPr>
            <p:cNvSpPr/>
            <p:nvPr/>
          </p:nvSpPr>
          <p:spPr>
            <a:xfrm>
              <a:off x="2505127" y="3393669"/>
              <a:ext cx="1441420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6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7 data</a:t>
              </a:r>
            </a:p>
            <a:p>
              <a:pPr algn="ctr"/>
              <a:r>
                <a:rPr lang="en-US" altLang="ko-KR" sz="16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,980 patients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7</Words>
  <Application>Microsoft Office PowerPoint</Application>
  <PresentationFormat>와이드스크린</PresentationFormat>
  <Paragraphs>1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HY신명조</vt:lpstr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손창규</dc:creator>
  <cp:lastModifiedBy>손창규</cp:lastModifiedBy>
  <cp:revision>2</cp:revision>
  <dcterms:created xsi:type="dcterms:W3CDTF">2023-07-05T06:39:50Z</dcterms:created>
  <dcterms:modified xsi:type="dcterms:W3CDTF">2023-07-15T06:15:01Z</dcterms:modified>
</cp:coreProperties>
</file>